
<file path=[Content_Types].xml><?xml version="1.0" encoding="utf-8"?>
<Types xmlns="http://schemas.openxmlformats.org/package/2006/content-types">
  <Default Extension="gif" ContentType="image/gi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7" r:id="rId3"/>
    <p:sldId id="256" r:id="rId4"/>
    <p:sldId id="258" r:id="rId5"/>
    <p:sldId id="259" r:id="rId6"/>
    <p:sldId id="261" r:id="rId7"/>
    <p:sldId id="262" r:id="rId8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EE4D3A6-B48B-4A4D-A4BE-F1FAFD738A3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48BEA0E8-ED28-4514-ABC0-C878134765A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217B047-B1AB-42ED-8B74-476C35C69A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547FC-518B-40B7-ABEC-E328F6AFFBB7}" type="datetimeFigureOut">
              <a:rPr lang="de-DE" smtClean="0"/>
              <a:t>08.03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95FD049-E6F3-4695-AC01-75231E74D6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F760B27-7801-4B2E-A0F2-A30A440770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CACC9-A6E4-4B03-AA3E-963BB6BCD30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027155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216ED8D-6193-4860-953F-855BB045BF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7BE45A1C-2FDE-4003-BC89-BE2F78F37F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DCA4452-3CAF-4410-80AC-6D31D12609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547FC-518B-40B7-ABEC-E328F6AFFBB7}" type="datetimeFigureOut">
              <a:rPr lang="de-DE" smtClean="0"/>
              <a:t>08.03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1E4A65B-C9EC-442E-AD2F-E00D8C87EC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855453C-80FA-4707-8DFB-FCA9671D8F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CACC9-A6E4-4B03-AA3E-963BB6BCD30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7137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ACE7A1E0-BCC0-4CD1-BF9C-70D23BD1CB4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B1A1DEC4-25E8-432A-9592-32B11496A1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A4EEEC5-6801-48E7-BC80-39330342B2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547FC-518B-40B7-ABEC-E328F6AFFBB7}" type="datetimeFigureOut">
              <a:rPr lang="de-DE" smtClean="0"/>
              <a:t>08.03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D6F3DBB-10B5-47DD-825E-0464B05AE6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94CD82D-CF1C-469F-ACBF-C038F80C5A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CACC9-A6E4-4B03-AA3E-963BB6BCD30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310313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43AF0FC-B657-42E0-852E-FD26F247D6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E19DB13E-9B7C-46A7-8B4E-300A58ADF14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E5E7F58-3677-4987-AA9C-99681F16B2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547FC-518B-40B7-ABEC-E328F6AFFBB7}" type="datetimeFigureOut">
              <a:rPr lang="de-DE" smtClean="0"/>
              <a:t>08.03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076257E-1F14-458A-8328-ACF413E85B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4D6C09A-22C2-4514-A393-461EA133E5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CACC9-A6E4-4B03-AA3E-963BB6BCD30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22123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27859A5-740E-48CD-9237-3EE4BA7006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B14576C-8C6E-4BCA-8FBC-E0A3C8E049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1670A28-0C53-461E-9107-C0B84B150C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547FC-518B-40B7-ABEC-E328F6AFFBB7}" type="datetimeFigureOut">
              <a:rPr lang="de-DE" smtClean="0"/>
              <a:t>08.03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6908212-B9AF-4CA7-A7BC-2BE67D6B24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65D6D91-2BCB-4562-89EE-A0D901609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CACC9-A6E4-4B03-AA3E-963BB6BCD30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80661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D19E921-12A2-4742-B1F2-65E30EAB97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FBECF65-9630-4598-A8F2-8939ED09E80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C731F6DC-519F-4E5A-8000-C9126AB7B1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1692CDA-A27E-4DBB-9C01-5FBFB48C49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547FC-518B-40B7-ABEC-E328F6AFFBB7}" type="datetimeFigureOut">
              <a:rPr lang="de-DE" smtClean="0"/>
              <a:t>08.03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F5AAA27-1147-4984-BD11-CB355BFDB6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B8E7ECD-107D-4D9B-87ED-C384346D3A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CACC9-A6E4-4B03-AA3E-963BB6BCD30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270690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9E7EBAE-872B-4A48-A4E4-F7A938D455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25639D6-E344-4D65-84FC-7FC8A20C30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1999E3B4-C33B-498F-9C08-BAF3B26BE1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F99A43D2-FEE8-46A8-8EBF-A4C01E6A473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4FA75D0E-7856-41CC-98F9-DD9FCB8BCE8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115281EB-C9E0-4CEE-98F0-98474AAB86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547FC-518B-40B7-ABEC-E328F6AFFBB7}" type="datetimeFigureOut">
              <a:rPr lang="de-DE" smtClean="0"/>
              <a:t>08.03.20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317DED5F-BAE7-4479-AAC2-56057316C6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F877DC59-48A0-47ED-9056-B8000DF39A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CACC9-A6E4-4B03-AA3E-963BB6BCD30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71099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BEAE375-4FC9-4DF4-85A7-7D9553D34A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2EE6D3B4-0DBB-419C-AD4C-CA71A71537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547FC-518B-40B7-ABEC-E328F6AFFBB7}" type="datetimeFigureOut">
              <a:rPr lang="de-DE" smtClean="0"/>
              <a:t>08.03.20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3FFA71CD-EE45-4A4B-8B60-A61F54236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353542CA-3F10-446F-9AC8-870AC6995F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CACC9-A6E4-4B03-AA3E-963BB6BCD30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14943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F19C7D8B-575C-4BC3-89D4-D28A568907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547FC-518B-40B7-ABEC-E328F6AFFBB7}" type="datetimeFigureOut">
              <a:rPr lang="de-DE" smtClean="0"/>
              <a:t>08.03.20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96FCD4C8-61FD-47B1-B95C-E71C9F0151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88ADAAB3-93CD-4F13-88F7-FE9F14C311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CACC9-A6E4-4B03-AA3E-963BB6BCD30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95137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8B67014-7159-48E6-A4C2-BB15D017A3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28138DA-77A3-4E19-8862-2BFBF1A03B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C3F88003-2CF7-4C04-9070-457B2CB0C81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982C9BF-CFDA-4AF4-844C-3E8ADF283D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547FC-518B-40B7-ABEC-E328F6AFFBB7}" type="datetimeFigureOut">
              <a:rPr lang="de-DE" smtClean="0"/>
              <a:t>08.03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2B6E59FE-DF45-4F5B-8F78-1B7169A080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D7B534F-D23D-444C-8839-23F5F1B4B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CACC9-A6E4-4B03-AA3E-963BB6BCD30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597492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FC2D75E-2EC4-4172-A2FE-40216BE93A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01588380-227E-4B9F-9546-0411B62110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13B367E5-818D-443F-B4B0-A9EE881AB9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4F32863-77D4-4266-AF33-F5DCA6719F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547FC-518B-40B7-ABEC-E328F6AFFBB7}" type="datetimeFigureOut">
              <a:rPr lang="de-DE" smtClean="0"/>
              <a:t>08.03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3066B8D-7F32-46D7-9D5F-8779AD9562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598E6E4-4EBF-4537-BB34-32582383D4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CACC9-A6E4-4B03-AA3E-963BB6BCD30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19273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ABB0AFE8-F6A0-48ED-865A-3C0A6BEE07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5B28180-06AC-4BA0-8EC5-B7E31269A8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B3B474E-9C9A-40F5-B324-552CABA3059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6547FC-518B-40B7-ABEC-E328F6AFFBB7}" type="datetimeFigureOut">
              <a:rPr lang="de-DE" smtClean="0"/>
              <a:t>08.03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A4DBFC9-9C40-462F-86B5-C7281878035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23034D8-1B52-4C12-BD92-BFC22290789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DCACC9-A6E4-4B03-AA3E-963BB6BCD303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29491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gif"/><Relationship Id="rId2" Type="http://schemas.openxmlformats.org/officeDocument/2006/relationships/image" Target="../media/image5.g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gif"/><Relationship Id="rId2" Type="http://schemas.openxmlformats.org/officeDocument/2006/relationships/image" Target="../media/image6.g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gif"/><Relationship Id="rId2" Type="http://schemas.openxmlformats.org/officeDocument/2006/relationships/image" Target="../media/image8.g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g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gif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5.tiff"/><Relationship Id="rId4" Type="http://schemas.openxmlformats.org/officeDocument/2006/relationships/image" Target="../media/image14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1CA12B79-48C7-442F-AB42-1BA56A024BC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7288" y="231897"/>
            <a:ext cx="5879305" cy="2964416"/>
          </a:xfrm>
          <a:prstGeom prst="rect">
            <a:avLst/>
          </a:prstGeom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id="{6878B8AC-74B6-47CC-B443-15BF354C09D6}"/>
              </a:ext>
            </a:extLst>
          </p:cNvPr>
          <p:cNvSpPr txBox="1"/>
          <p:nvPr/>
        </p:nvSpPr>
        <p:spPr>
          <a:xfrm>
            <a:off x="6428934" y="469887"/>
            <a:ext cx="540611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S1: </a:t>
            </a:r>
            <a:r>
              <a:rPr lang="de-DE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yHeart4Fish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er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uide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rimary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e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terface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te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figuration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reviews of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rt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tat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sie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a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lectio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llowing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ep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Definition of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rium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ntricl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ia „Drag and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lect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“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ptio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rea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lectio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ppli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am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977F22BA-4DE3-4803-95C5-0A47016C0BBB}"/>
              </a:ext>
            </a:extLst>
          </p:cNvPr>
          <p:cNvSpPr txBox="1"/>
          <p:nvPr/>
        </p:nvSpPr>
        <p:spPr>
          <a:xfrm>
            <a:off x="25787" y="10055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grpSp>
        <p:nvGrpSpPr>
          <p:cNvPr id="24" name="Gruppieren 23">
            <a:extLst>
              <a:ext uri="{FF2B5EF4-FFF2-40B4-BE49-F238E27FC236}">
                <a16:creationId xmlns:a16="http://schemas.microsoft.com/office/drawing/2014/main" id="{80DE3D57-1140-4F2E-8149-F3A307C1542B}"/>
              </a:ext>
            </a:extLst>
          </p:cNvPr>
          <p:cNvGrpSpPr/>
          <p:nvPr/>
        </p:nvGrpSpPr>
        <p:grpSpPr>
          <a:xfrm>
            <a:off x="118113" y="3429000"/>
            <a:ext cx="11830006" cy="2781043"/>
            <a:chOff x="19639" y="2871890"/>
            <a:chExt cx="11830006" cy="2781043"/>
          </a:xfrm>
        </p:grpSpPr>
        <p:sp>
          <p:nvSpPr>
            <p:cNvPr id="14" name="Textfeld 13">
              <a:extLst>
                <a:ext uri="{FF2B5EF4-FFF2-40B4-BE49-F238E27FC236}">
                  <a16:creationId xmlns:a16="http://schemas.microsoft.com/office/drawing/2014/main" id="{E561679F-4E2B-4F0D-96DE-2E64074CA234}"/>
                </a:ext>
              </a:extLst>
            </p:cNvPr>
            <p:cNvSpPr txBox="1"/>
            <p:nvPr/>
          </p:nvSpPr>
          <p:spPr>
            <a:xfrm>
              <a:off x="19639" y="2871890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15" name="Textfeld 14">
              <a:extLst>
                <a:ext uri="{FF2B5EF4-FFF2-40B4-BE49-F238E27FC236}">
                  <a16:creationId xmlns:a16="http://schemas.microsoft.com/office/drawing/2014/main" id="{6B4DFC44-A07D-44F1-B50F-1ED56A3FE580}"/>
                </a:ext>
              </a:extLst>
            </p:cNvPr>
            <p:cNvSpPr txBox="1"/>
            <p:nvPr/>
          </p:nvSpPr>
          <p:spPr>
            <a:xfrm>
              <a:off x="3954156" y="2871890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16" name="Textfeld 15">
              <a:extLst>
                <a:ext uri="{FF2B5EF4-FFF2-40B4-BE49-F238E27FC236}">
                  <a16:creationId xmlns:a16="http://schemas.microsoft.com/office/drawing/2014/main" id="{208AD9B4-B551-44BB-AE28-03AFE77CA208}"/>
                </a:ext>
              </a:extLst>
            </p:cNvPr>
            <p:cNvSpPr txBox="1"/>
            <p:nvPr/>
          </p:nvSpPr>
          <p:spPr>
            <a:xfrm>
              <a:off x="7915128" y="2871890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grpSp>
          <p:nvGrpSpPr>
            <p:cNvPr id="23" name="Gruppieren 22">
              <a:extLst>
                <a:ext uri="{FF2B5EF4-FFF2-40B4-BE49-F238E27FC236}">
                  <a16:creationId xmlns:a16="http://schemas.microsoft.com/office/drawing/2014/main" id="{FFBB1327-6712-43DA-BB73-46E35FDC3649}"/>
                </a:ext>
              </a:extLst>
            </p:cNvPr>
            <p:cNvGrpSpPr/>
            <p:nvPr/>
          </p:nvGrpSpPr>
          <p:grpSpPr>
            <a:xfrm>
              <a:off x="371017" y="2956639"/>
              <a:ext cx="11478628" cy="2696294"/>
              <a:chOff x="210639" y="4152684"/>
              <a:chExt cx="11478628" cy="2696294"/>
            </a:xfrm>
          </p:grpSpPr>
          <p:pic>
            <p:nvPicPr>
              <p:cNvPr id="18" name="Grafik 17">
                <a:extLst>
                  <a:ext uri="{FF2B5EF4-FFF2-40B4-BE49-F238E27FC236}">
                    <a16:creationId xmlns:a16="http://schemas.microsoft.com/office/drawing/2014/main" id="{F20E5063-81B4-4DC6-BABC-4BA14909BD9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0639" y="4155703"/>
                <a:ext cx="3556684" cy="2681100"/>
              </a:xfrm>
              <a:prstGeom prst="rect">
                <a:avLst/>
              </a:prstGeom>
            </p:spPr>
          </p:pic>
          <p:pic>
            <p:nvPicPr>
              <p:cNvPr id="20" name="Grafik 19">
                <a:extLst>
                  <a:ext uri="{FF2B5EF4-FFF2-40B4-BE49-F238E27FC236}">
                    <a16:creationId xmlns:a16="http://schemas.microsoft.com/office/drawing/2014/main" id="{CE26800F-F04B-44A0-84FE-1BFFE7661E4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71611" y="4152684"/>
                <a:ext cx="3556684" cy="2696294"/>
              </a:xfrm>
              <a:prstGeom prst="rect">
                <a:avLst/>
              </a:prstGeom>
            </p:spPr>
          </p:pic>
          <p:pic>
            <p:nvPicPr>
              <p:cNvPr id="22" name="Grafik 21">
                <a:extLst>
                  <a:ext uri="{FF2B5EF4-FFF2-40B4-BE49-F238E27FC236}">
                    <a16:creationId xmlns:a16="http://schemas.microsoft.com/office/drawing/2014/main" id="{AB0BB5A0-CBC0-475C-B049-C04FC28E190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132583" y="4152684"/>
                <a:ext cx="3556684" cy="2687139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301885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>
            <a:extLst>
              <a:ext uri="{FF2B5EF4-FFF2-40B4-BE49-F238E27FC236}">
                <a16:creationId xmlns:a16="http://schemas.microsoft.com/office/drawing/2014/main" id="{A3410A2C-4E6C-487F-B5C9-8073BD8AA207}"/>
              </a:ext>
            </a:extLst>
          </p:cNvPr>
          <p:cNvGrpSpPr/>
          <p:nvPr/>
        </p:nvGrpSpPr>
        <p:grpSpPr>
          <a:xfrm>
            <a:off x="586152" y="655342"/>
            <a:ext cx="10330029" cy="4807634"/>
            <a:chOff x="790134" y="606104"/>
            <a:chExt cx="10330029" cy="4807634"/>
          </a:xfrm>
        </p:grpSpPr>
        <p:grpSp>
          <p:nvGrpSpPr>
            <p:cNvPr id="2" name="Gruppieren 1">
              <a:extLst>
                <a:ext uri="{FF2B5EF4-FFF2-40B4-BE49-F238E27FC236}">
                  <a16:creationId xmlns:a16="http://schemas.microsoft.com/office/drawing/2014/main" id="{C1F2F8D1-15B5-4909-A56A-E3B4BCE385A3}"/>
                </a:ext>
              </a:extLst>
            </p:cNvPr>
            <p:cNvGrpSpPr/>
            <p:nvPr/>
          </p:nvGrpSpPr>
          <p:grpSpPr>
            <a:xfrm>
              <a:off x="5024163" y="606104"/>
              <a:ext cx="6096000" cy="4807634"/>
              <a:chOff x="5024163" y="606104"/>
              <a:chExt cx="6096000" cy="4807634"/>
            </a:xfrm>
          </p:grpSpPr>
          <p:pic>
            <p:nvPicPr>
              <p:cNvPr id="3" name="Grafik 2">
                <a:extLst>
                  <a:ext uri="{FF2B5EF4-FFF2-40B4-BE49-F238E27FC236}">
                    <a16:creationId xmlns:a16="http://schemas.microsoft.com/office/drawing/2014/main" id="{473B1046-7FEE-4A67-9B9A-FBCD69E8202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024163" y="841738"/>
                <a:ext cx="6096000" cy="4572000"/>
              </a:xfrm>
              <a:prstGeom prst="rect">
                <a:avLst/>
              </a:prstGeom>
            </p:spPr>
          </p:pic>
          <p:sp>
            <p:nvSpPr>
              <p:cNvPr id="11" name="Textfeld 10">
                <a:extLst>
                  <a:ext uri="{FF2B5EF4-FFF2-40B4-BE49-F238E27FC236}">
                    <a16:creationId xmlns:a16="http://schemas.microsoft.com/office/drawing/2014/main" id="{F56CC13B-19CB-458F-956F-4219A50EC88C}"/>
                  </a:ext>
                </a:extLst>
              </p:cNvPr>
              <p:cNvSpPr txBox="1"/>
              <p:nvPr/>
            </p:nvSpPr>
            <p:spPr>
              <a:xfrm>
                <a:off x="7051562" y="606104"/>
                <a:ext cx="229421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ycloheximide</a:t>
                </a:r>
                <a:r>
                  <a:rPr lang="de-DE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(CHX)</a:t>
                </a:r>
              </a:p>
            </p:txBody>
          </p:sp>
        </p:grpSp>
        <p:grpSp>
          <p:nvGrpSpPr>
            <p:cNvPr id="6" name="Gruppieren 5">
              <a:extLst>
                <a:ext uri="{FF2B5EF4-FFF2-40B4-BE49-F238E27FC236}">
                  <a16:creationId xmlns:a16="http://schemas.microsoft.com/office/drawing/2014/main" id="{8856F109-0F4E-4F20-9458-49B0764E4CAE}"/>
                </a:ext>
              </a:extLst>
            </p:cNvPr>
            <p:cNvGrpSpPr/>
            <p:nvPr/>
          </p:nvGrpSpPr>
          <p:grpSpPr>
            <a:xfrm>
              <a:off x="790134" y="657072"/>
              <a:ext cx="6096000" cy="4705698"/>
              <a:chOff x="227427" y="776647"/>
              <a:chExt cx="6096000" cy="4705698"/>
            </a:xfrm>
          </p:grpSpPr>
          <p:pic>
            <p:nvPicPr>
              <p:cNvPr id="7" name="Grafik 6">
                <a:extLst>
                  <a:ext uri="{FF2B5EF4-FFF2-40B4-BE49-F238E27FC236}">
                    <a16:creationId xmlns:a16="http://schemas.microsoft.com/office/drawing/2014/main" id="{B202A0E0-F4E8-441B-8D57-847D673CB1E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27427" y="910345"/>
                <a:ext cx="6096000" cy="4572000"/>
              </a:xfrm>
              <a:prstGeom prst="rect">
                <a:avLst/>
              </a:prstGeom>
            </p:spPr>
          </p:pic>
          <p:sp>
            <p:nvSpPr>
              <p:cNvPr id="8" name="Textfeld 7">
                <a:extLst>
                  <a:ext uri="{FF2B5EF4-FFF2-40B4-BE49-F238E27FC236}">
                    <a16:creationId xmlns:a16="http://schemas.microsoft.com/office/drawing/2014/main" id="{0379127D-97DF-4525-AB57-FEAA457B2B2E}"/>
                  </a:ext>
                </a:extLst>
              </p:cNvPr>
              <p:cNvSpPr txBox="1"/>
              <p:nvPr/>
            </p:nvSpPr>
            <p:spPr>
              <a:xfrm>
                <a:off x="2561245" y="776647"/>
                <a:ext cx="139012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.2% DMSO</a:t>
                </a:r>
              </a:p>
            </p:txBody>
          </p:sp>
        </p:grpSp>
      </p:grpSp>
      <p:sp>
        <p:nvSpPr>
          <p:cNvPr id="12" name="Textfeld 11">
            <a:extLst>
              <a:ext uri="{FF2B5EF4-FFF2-40B4-BE49-F238E27FC236}">
                <a16:creationId xmlns:a16="http://schemas.microsoft.com/office/drawing/2014/main" id="{84ADCAEF-84D0-4529-B370-6E1D334340F4}"/>
              </a:ext>
            </a:extLst>
          </p:cNvPr>
          <p:cNvSpPr txBox="1"/>
          <p:nvPr/>
        </p:nvSpPr>
        <p:spPr>
          <a:xfrm>
            <a:off x="478302" y="5318371"/>
            <a:ext cx="1141124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S2: CHX-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uced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adycardia</a:t>
            </a:r>
            <a:endParaRPr lang="de-D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IF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utput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le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yHeart4Fish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MSO and CHX. Heart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z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relative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ntricl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actility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ificantly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duc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CHX-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mbryo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urthermor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CHX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uc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ificant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adycardia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b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ue =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ect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ntricl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a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ect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rium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a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tt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n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ROI; 1/35 =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ames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24804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DADE18AC-2D59-44FD-8FA7-CC45C8EA3453}"/>
              </a:ext>
            </a:extLst>
          </p:cNvPr>
          <p:cNvGrpSpPr/>
          <p:nvPr/>
        </p:nvGrpSpPr>
        <p:grpSpPr>
          <a:xfrm>
            <a:off x="583810" y="711149"/>
            <a:ext cx="6096000" cy="4705698"/>
            <a:chOff x="227427" y="776647"/>
            <a:chExt cx="6096000" cy="4705698"/>
          </a:xfrm>
        </p:grpSpPr>
        <p:pic>
          <p:nvPicPr>
            <p:cNvPr id="9" name="Grafik 8">
              <a:extLst>
                <a:ext uri="{FF2B5EF4-FFF2-40B4-BE49-F238E27FC236}">
                  <a16:creationId xmlns:a16="http://schemas.microsoft.com/office/drawing/2014/main" id="{5311139F-8F90-47BE-A41A-CAF91A75F2E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7427" y="910345"/>
              <a:ext cx="6096000" cy="4572000"/>
            </a:xfrm>
            <a:prstGeom prst="rect">
              <a:avLst/>
            </a:prstGeom>
          </p:spPr>
        </p:pic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92CD99F9-527E-43DE-8B6C-CA0B1D90B1E7}"/>
                </a:ext>
              </a:extLst>
            </p:cNvPr>
            <p:cNvSpPr txBox="1"/>
            <p:nvPr/>
          </p:nvSpPr>
          <p:spPr>
            <a:xfrm>
              <a:off x="2561245" y="776647"/>
              <a:ext cx="13901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% DMSO</a:t>
              </a:r>
            </a:p>
          </p:txBody>
        </p:sp>
      </p:grpSp>
      <p:grpSp>
        <p:nvGrpSpPr>
          <p:cNvPr id="3" name="Gruppieren 2">
            <a:extLst>
              <a:ext uri="{FF2B5EF4-FFF2-40B4-BE49-F238E27FC236}">
                <a16:creationId xmlns:a16="http://schemas.microsoft.com/office/drawing/2014/main" id="{86C65B8D-FA9C-4985-A23E-994E53E77935}"/>
              </a:ext>
            </a:extLst>
          </p:cNvPr>
          <p:cNvGrpSpPr/>
          <p:nvPr/>
        </p:nvGrpSpPr>
        <p:grpSpPr>
          <a:xfrm>
            <a:off x="4840360" y="711149"/>
            <a:ext cx="6096000" cy="4705698"/>
            <a:chOff x="4840360" y="612673"/>
            <a:chExt cx="6096000" cy="4705698"/>
          </a:xfrm>
        </p:grpSpPr>
        <p:pic>
          <p:nvPicPr>
            <p:cNvPr id="7" name="Grafik 6">
              <a:extLst>
                <a:ext uri="{FF2B5EF4-FFF2-40B4-BE49-F238E27FC236}">
                  <a16:creationId xmlns:a16="http://schemas.microsoft.com/office/drawing/2014/main" id="{AE7FFD16-3402-41D1-B024-222282921FA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40360" y="746371"/>
              <a:ext cx="6096000" cy="4572000"/>
            </a:xfrm>
            <a:prstGeom prst="rect">
              <a:avLst/>
            </a:prstGeom>
          </p:spPr>
        </p:pic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F56CC13B-19CB-458F-956F-4219A50EC88C}"/>
                </a:ext>
              </a:extLst>
            </p:cNvPr>
            <p:cNvSpPr txBox="1"/>
            <p:nvPr/>
          </p:nvSpPr>
          <p:spPr>
            <a:xfrm>
              <a:off x="6364939" y="612673"/>
              <a:ext cx="305268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Pentamidine</a:t>
              </a:r>
              <a:r>
                <a:rPr lang="de-DE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de-DE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isethionate</a:t>
              </a:r>
              <a:r>
                <a:rPr lang="de-DE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PEN)</a:t>
              </a:r>
            </a:p>
          </p:txBody>
        </p:sp>
      </p:grpSp>
      <p:sp>
        <p:nvSpPr>
          <p:cNvPr id="6" name="Textfeld 5">
            <a:extLst>
              <a:ext uri="{FF2B5EF4-FFF2-40B4-BE49-F238E27FC236}">
                <a16:creationId xmlns:a16="http://schemas.microsoft.com/office/drawing/2014/main" id="{5C6256F3-55C6-4992-9887-E73DCD703229}"/>
              </a:ext>
            </a:extLst>
          </p:cNvPr>
          <p:cNvSpPr txBox="1"/>
          <p:nvPr/>
        </p:nvSpPr>
        <p:spPr>
          <a:xfrm>
            <a:off x="478302" y="5318371"/>
            <a:ext cx="1141124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S3: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rial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actility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enotype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PEN</a:t>
            </a:r>
          </a:p>
          <a:p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IF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utput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le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yHeart4Fish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MSO and PEN.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osur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0.2%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ot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ng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actility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rium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ntricl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weve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EN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sult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duc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rium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actility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b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ue =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ect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ntricl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a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ect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rium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a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tt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n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ROI; 1/35 =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ames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36304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654301A4-50B9-4B36-8683-C2A3E53797E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93057" y="844847"/>
            <a:ext cx="6096000" cy="4572000"/>
          </a:xfrm>
          <a:prstGeom prst="rect">
            <a:avLst/>
          </a:prstGeom>
        </p:spPr>
      </p:pic>
      <p:grpSp>
        <p:nvGrpSpPr>
          <p:cNvPr id="6" name="Gruppieren 5">
            <a:extLst>
              <a:ext uri="{FF2B5EF4-FFF2-40B4-BE49-F238E27FC236}">
                <a16:creationId xmlns:a16="http://schemas.microsoft.com/office/drawing/2014/main" id="{2FF8BCAF-20E4-417A-AE2B-C06C2DD41E9C}"/>
              </a:ext>
            </a:extLst>
          </p:cNvPr>
          <p:cNvGrpSpPr/>
          <p:nvPr/>
        </p:nvGrpSpPr>
        <p:grpSpPr>
          <a:xfrm>
            <a:off x="583810" y="711149"/>
            <a:ext cx="6096000" cy="4705698"/>
            <a:chOff x="227427" y="776647"/>
            <a:chExt cx="6096000" cy="4705698"/>
          </a:xfrm>
        </p:grpSpPr>
        <p:pic>
          <p:nvPicPr>
            <p:cNvPr id="7" name="Grafik 6">
              <a:extLst>
                <a:ext uri="{FF2B5EF4-FFF2-40B4-BE49-F238E27FC236}">
                  <a16:creationId xmlns:a16="http://schemas.microsoft.com/office/drawing/2014/main" id="{D5DA9471-8561-49F0-AA2D-525040D00873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7427" y="910345"/>
              <a:ext cx="6096000" cy="4572000"/>
            </a:xfrm>
            <a:prstGeom prst="rect">
              <a:avLst/>
            </a:prstGeom>
          </p:spPr>
        </p:pic>
        <p:sp>
          <p:nvSpPr>
            <p:cNvPr id="8" name="Textfeld 7">
              <a:extLst>
                <a:ext uri="{FF2B5EF4-FFF2-40B4-BE49-F238E27FC236}">
                  <a16:creationId xmlns:a16="http://schemas.microsoft.com/office/drawing/2014/main" id="{4FF27D40-CAA2-43D7-9E71-9F14DED5A7AF}"/>
                </a:ext>
              </a:extLst>
            </p:cNvPr>
            <p:cNvSpPr txBox="1"/>
            <p:nvPr/>
          </p:nvSpPr>
          <p:spPr>
            <a:xfrm>
              <a:off x="2561245" y="776647"/>
              <a:ext cx="13901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% DMSO</a:t>
              </a:r>
            </a:p>
          </p:txBody>
        </p:sp>
      </p:grpSp>
      <p:sp>
        <p:nvSpPr>
          <p:cNvPr id="11" name="Textfeld 10">
            <a:extLst>
              <a:ext uri="{FF2B5EF4-FFF2-40B4-BE49-F238E27FC236}">
                <a16:creationId xmlns:a16="http://schemas.microsoft.com/office/drawing/2014/main" id="{F56CC13B-19CB-458F-956F-4219A50EC88C}"/>
              </a:ext>
            </a:extLst>
          </p:cNvPr>
          <p:cNvSpPr txBox="1"/>
          <p:nvPr/>
        </p:nvSpPr>
        <p:spPr>
          <a:xfrm>
            <a:off x="6704438" y="708632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nzydamine HCl (BZY)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C5459DBB-DF93-466D-AC63-939D08BEDF61}"/>
              </a:ext>
            </a:extLst>
          </p:cNvPr>
          <p:cNvSpPr txBox="1"/>
          <p:nvPr/>
        </p:nvSpPr>
        <p:spPr>
          <a:xfrm>
            <a:off x="478302" y="5318371"/>
            <a:ext cx="1141124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S4: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ZY‘s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ffect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rt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unction</a:t>
            </a:r>
            <a:endParaRPr lang="de-D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de-DE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yHeart4Fish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utput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le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GIF) after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MSO and BZY. Treatment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ZY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ot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ng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rt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z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weve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t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duc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x.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rium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latio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urthermor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ntricl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act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ificantly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r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an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ol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b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ue =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ect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ntricl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a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ect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rium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a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tt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n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ROI; 1/35 =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ames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56444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uppieren 12">
            <a:extLst>
              <a:ext uri="{FF2B5EF4-FFF2-40B4-BE49-F238E27FC236}">
                <a16:creationId xmlns:a16="http://schemas.microsoft.com/office/drawing/2014/main" id="{0E0DA871-D47C-431B-9D72-9B7E37763974}"/>
              </a:ext>
            </a:extLst>
          </p:cNvPr>
          <p:cNvGrpSpPr/>
          <p:nvPr/>
        </p:nvGrpSpPr>
        <p:grpSpPr>
          <a:xfrm>
            <a:off x="78556" y="859078"/>
            <a:ext cx="6096000" cy="4673042"/>
            <a:chOff x="78556" y="859078"/>
            <a:chExt cx="6096000" cy="4673042"/>
          </a:xfrm>
        </p:grpSpPr>
        <p:pic>
          <p:nvPicPr>
            <p:cNvPr id="12" name="Grafik 11">
              <a:extLst>
                <a:ext uri="{FF2B5EF4-FFF2-40B4-BE49-F238E27FC236}">
                  <a16:creationId xmlns:a16="http://schemas.microsoft.com/office/drawing/2014/main" id="{EEC6956F-DDE6-4568-B023-6258FB3F472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556" y="960120"/>
              <a:ext cx="6096000" cy="4572000"/>
            </a:xfrm>
            <a:prstGeom prst="rect">
              <a:avLst/>
            </a:prstGeom>
          </p:spPr>
        </p:pic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F56CC13B-19CB-458F-956F-4219A50EC88C}"/>
                </a:ext>
              </a:extLst>
            </p:cNvPr>
            <p:cNvSpPr txBox="1"/>
            <p:nvPr/>
          </p:nvSpPr>
          <p:spPr>
            <a:xfrm>
              <a:off x="1872045" y="859078"/>
              <a:ext cx="27238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R)-</a:t>
              </a:r>
              <a:r>
                <a:rPr lang="de-DE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Duloxetine</a:t>
              </a:r>
              <a:r>
                <a:rPr lang="de-DE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HCl (DLX)</a:t>
              </a:r>
            </a:p>
          </p:txBody>
        </p:sp>
      </p:grpSp>
      <p:pic>
        <p:nvPicPr>
          <p:cNvPr id="15" name="Grafik 14">
            <a:extLst>
              <a:ext uri="{FF2B5EF4-FFF2-40B4-BE49-F238E27FC236}">
                <a16:creationId xmlns:a16="http://schemas.microsoft.com/office/drawing/2014/main" id="{9BE77C49-909D-4168-A2F0-4664C959770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5628" y="1352254"/>
            <a:ext cx="6312886" cy="3787732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9D294A4D-D698-41A0-A41E-E86FB8CF53E7}"/>
              </a:ext>
            </a:extLst>
          </p:cNvPr>
          <p:cNvSpPr txBox="1"/>
          <p:nvPr/>
        </p:nvSpPr>
        <p:spPr>
          <a:xfrm>
            <a:off x="478302" y="5318371"/>
            <a:ext cx="1141124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S5: DLX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uced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rial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utter</a:t>
            </a:r>
            <a:endParaRPr lang="de-D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de-DE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yHeart4Fish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at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LX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uc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rial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utte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ebrafish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mbryo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 dpf. Regular but fast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action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rregula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ensity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bserv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rium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hil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ntricl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llow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gula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ne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hythm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gular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action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b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ue box =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ect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ntricl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a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ox=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tect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rium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ea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tt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n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ROI; 1/35 =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ames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lack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n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w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nal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ott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ne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tted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ne </a:t>
            </a:r>
            <a:r>
              <a:rPr lang="de-D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unction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48993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9D294A4D-D698-41A0-A41E-E86FB8CF53E7}"/>
              </a:ext>
            </a:extLst>
          </p:cNvPr>
          <p:cNvSpPr txBox="1"/>
          <p:nvPr/>
        </p:nvSpPr>
        <p:spPr>
          <a:xfrm>
            <a:off x="478302" y="5318371"/>
            <a:ext cx="1141124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6: Correlation analysis of intra- and inter-assay variability</a:t>
            </a:r>
          </a:p>
          <a:p>
            <a:r>
              <a:rPr lang="en-US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The variability of output parameters derived from pyHeart4Fish were analyzed using the Pearson correlation coefficient r (as implemented in the Python module scipy.stats.pearsonr). Intra-assay variability (left panel) was assessed for 85 zebrafish movies analyzed independently by two different users. Biological variation (right panel) was derived from pair-wise comparison of 2 – 13 replications representing 561 zebrafish. Replications were plotted against one another. Outliers (shown in gray) with more than 3-fold y standard deviation from the regression curve were not considered in the calculation of the Pearson correlation coefficient. Red line = linear regression curve correlation; black dots = raw data of a single fish; gray dots = outliers; blue dots = DMSO controls; Atr. = atrium; Ventr. = ventricle; Contr = Contractility; EF = Ejection Fraction; FFT = Fast Fourier Transformation</a:t>
            </a:r>
          </a:p>
        </p:txBody>
      </p:sp>
      <p:pic>
        <p:nvPicPr>
          <p:cNvPr id="13" name="Picture 12" descr="Chart, scatter chart&#10;&#10;Description automatically generated with medium confidence">
            <a:extLst>
              <a:ext uri="{FF2B5EF4-FFF2-40B4-BE49-F238E27FC236}">
                <a16:creationId xmlns:a16="http://schemas.microsoft.com/office/drawing/2014/main" id="{89F12961-FF6B-8F08-4A87-3E2D718CCA6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302" y="430537"/>
            <a:ext cx="9577761" cy="48878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066001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9D294A4D-D698-41A0-A41E-E86FB8CF53E7}"/>
              </a:ext>
            </a:extLst>
          </p:cNvPr>
          <p:cNvSpPr txBox="1"/>
          <p:nvPr/>
        </p:nvSpPr>
        <p:spPr>
          <a:xfrm>
            <a:off x="267939" y="5554373"/>
            <a:ext cx="1141124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7: Heart rate at increasing compound concentrations</a:t>
            </a:r>
          </a:p>
          <a:p>
            <a:r>
              <a:rPr lang="en-US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A) Heart rates of zebrafish embryos (48 hpf) were determined using the brightfield module of </a:t>
            </a:r>
            <a:r>
              <a:rPr lang="en-US" sz="1200" i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pyHeart4Fish </a:t>
            </a:r>
            <a:r>
              <a:rPr lang="en-US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and are shown as z-scores. DMSO-treated zebrafish embryos served as control. Data were fitted (red line) using the python module </a:t>
            </a:r>
            <a:r>
              <a:rPr lang="en-US" sz="1200" i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seaborn.regplot</a:t>
            </a:r>
            <a:r>
              <a:rPr lang="en-US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 B) Exemplary outputs of the brightfield module of </a:t>
            </a:r>
            <a:r>
              <a:rPr lang="en-US" sz="1200" i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pyHeart4Fish. </a:t>
            </a:r>
            <a:r>
              <a:rPr lang="en-US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The heart area is determined fully automatically. Freq = Frequency; FFT = Fast Fourier Transformation.</a:t>
            </a:r>
          </a:p>
        </p:txBody>
      </p:sp>
      <p:pic>
        <p:nvPicPr>
          <p:cNvPr id="10" name="Picture 9" descr="Graphical user interface&#10;&#10;Description automatically generated">
            <a:extLst>
              <a:ext uri="{FF2B5EF4-FFF2-40B4-BE49-F238E27FC236}">
                <a16:creationId xmlns:a16="http://schemas.microsoft.com/office/drawing/2014/main" id="{D75D8A73-F9A6-B0C3-443B-AF30D3A5623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42837" y="3295999"/>
            <a:ext cx="3387561" cy="2258374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BB159466-967B-ECAF-BBE4-FC704C7A1F55}"/>
              </a:ext>
            </a:extLst>
          </p:cNvPr>
          <p:cNvSpPr txBox="1"/>
          <p:nvPr/>
        </p:nvSpPr>
        <p:spPr>
          <a:xfrm>
            <a:off x="255239" y="203200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b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4DF4B17-F32F-6780-689F-57ADAD7D9222}"/>
              </a:ext>
            </a:extLst>
          </p:cNvPr>
          <p:cNvSpPr txBox="1"/>
          <p:nvPr/>
        </p:nvSpPr>
        <p:spPr>
          <a:xfrm>
            <a:off x="8310563" y="203200"/>
            <a:ext cx="108108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b="1" dirty="0"/>
          </a:p>
        </p:txBody>
      </p:sp>
      <p:pic>
        <p:nvPicPr>
          <p:cNvPr id="16" name="Picture 15" descr="A picture containing application&#10;&#10;Description automatically generated">
            <a:extLst>
              <a:ext uri="{FF2B5EF4-FFF2-40B4-BE49-F238E27FC236}">
                <a16:creationId xmlns:a16="http://schemas.microsoft.com/office/drawing/2014/main" id="{23B485C7-61BE-A953-2D4F-F69B6E29163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51106" y="203200"/>
            <a:ext cx="2447925" cy="1835944"/>
          </a:xfrm>
          <a:prstGeom prst="rect">
            <a:avLst/>
          </a:prstGeom>
        </p:spPr>
      </p:pic>
      <p:pic>
        <p:nvPicPr>
          <p:cNvPr id="18" name="Picture 17" descr="A close-up of a human eye&#10;&#10;Description automatically generated with low confidence">
            <a:extLst>
              <a:ext uri="{FF2B5EF4-FFF2-40B4-BE49-F238E27FC236}">
                <a16:creationId xmlns:a16="http://schemas.microsoft.com/office/drawing/2014/main" id="{7E2AE2AB-4806-CC86-DAE7-8543F9C8307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05017" y="1698793"/>
            <a:ext cx="1972578" cy="1479434"/>
          </a:xfrm>
          <a:prstGeom prst="rect">
            <a:avLst/>
          </a:prstGeom>
        </p:spPr>
      </p:pic>
      <p:pic>
        <p:nvPicPr>
          <p:cNvPr id="3" name="Picture 2" descr="Diagram&#10;&#10;Description automatically generated">
            <a:extLst>
              <a:ext uri="{FF2B5EF4-FFF2-40B4-BE49-F238E27FC236}">
                <a16:creationId xmlns:a16="http://schemas.microsoft.com/office/drawing/2014/main" id="{767E65AE-0550-F59E-9583-AABB974ABC4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233" y="472630"/>
            <a:ext cx="7673894" cy="47961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68070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48</Words>
  <Application>Microsoft Office PowerPoint</Application>
  <PresentationFormat>Widescreen</PresentationFormat>
  <Paragraphs>27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Viviana Vedder</dc:creator>
  <cp:lastModifiedBy>Tobias Reinberger</cp:lastModifiedBy>
  <cp:revision>23</cp:revision>
  <dcterms:created xsi:type="dcterms:W3CDTF">2022-12-30T11:51:28Z</dcterms:created>
  <dcterms:modified xsi:type="dcterms:W3CDTF">2023-03-08T10:42:04Z</dcterms:modified>
</cp:coreProperties>
</file>